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2" r:id="rId4"/>
  </p:sldMasterIdLst>
  <p:sldIdLst>
    <p:sldId id="265" r:id="rId5"/>
    <p:sldId id="280" r:id="rId6"/>
    <p:sldId id="257" r:id="rId7"/>
    <p:sldId id="267" r:id="rId8"/>
    <p:sldId id="268" r:id="rId9"/>
    <p:sldId id="269" r:id="rId10"/>
    <p:sldId id="274" r:id="rId11"/>
    <p:sldId id="276" r:id="rId12"/>
    <p:sldId id="283" r:id="rId13"/>
    <p:sldId id="279" r:id="rId14"/>
    <p:sldId id="281" r:id="rId15"/>
    <p:sldId id="282" r:id="rId16"/>
    <p:sldId id="277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C90E00E-52E5-4D41-9152-CA9485C48B60}" v="90" dt="2025-09-22T02:29:49.26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773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presProps" Target="presProps.xml"/><Relationship Id="rId3" Type="http://schemas.openxmlformats.org/officeDocument/2006/relationships/customXml" Target="../customXml/item3.xml"/><Relationship Id="rId21" Type="http://schemas.openxmlformats.org/officeDocument/2006/relationships/tableStyles" Target="tableStyle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microsoft.com/office/2015/10/relationships/revisionInfo" Target="revisionInfo.xml"/><Relationship Id="rId10" Type="http://schemas.openxmlformats.org/officeDocument/2006/relationships/slide" Target="slides/slide6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wati Jagani" userId="S::taitu77@clm.uni-hohenheim.de::1a613237-4fad-448a-82cf-176af2d8d863" providerId="AD" clId="Web-{8C90E00E-52E5-4D41-9152-CA9485C48B60}"/>
    <pc:docChg chg="modSld">
      <pc:chgData name="Swati Jagani" userId="S::taitu77@clm.uni-hohenheim.de::1a613237-4fad-448a-82cf-176af2d8d863" providerId="AD" clId="Web-{8C90E00E-52E5-4D41-9152-CA9485C48B60}" dt="2025-09-22T02:29:49.264" v="90" actId="20577"/>
      <pc:docMkLst>
        <pc:docMk/>
      </pc:docMkLst>
      <pc:sldChg chg="modSp">
        <pc:chgData name="Swati Jagani" userId="S::taitu77@clm.uni-hohenheim.de::1a613237-4fad-448a-82cf-176af2d8d863" providerId="AD" clId="Web-{8C90E00E-52E5-4D41-9152-CA9485C48B60}" dt="2025-09-22T02:19:04.833" v="2" actId="14100"/>
        <pc:sldMkLst>
          <pc:docMk/>
          <pc:sldMk cId="935162302" sldId="267"/>
        </pc:sldMkLst>
        <pc:picChg chg="mod modCrop">
          <ac:chgData name="Swati Jagani" userId="S::taitu77@clm.uni-hohenheim.de::1a613237-4fad-448a-82cf-176af2d8d863" providerId="AD" clId="Web-{8C90E00E-52E5-4D41-9152-CA9485C48B60}" dt="2025-09-22T02:19:04.833" v="2" actId="14100"/>
          <ac:picMkLst>
            <pc:docMk/>
            <pc:sldMk cId="935162302" sldId="267"/>
            <ac:picMk id="2" creationId="{00000000-0000-0000-0000-000000000000}"/>
          </ac:picMkLst>
        </pc:picChg>
      </pc:sldChg>
      <pc:sldChg chg="modSp">
        <pc:chgData name="Swati Jagani" userId="S::taitu77@clm.uni-hohenheim.de::1a613237-4fad-448a-82cf-176af2d8d863" providerId="AD" clId="Web-{8C90E00E-52E5-4D41-9152-CA9485C48B60}" dt="2025-09-22T02:21:42.592" v="10"/>
        <pc:sldMkLst>
          <pc:docMk/>
          <pc:sldMk cId="2146081360" sldId="277"/>
        </pc:sldMkLst>
        <pc:picChg chg="mod modCrop">
          <ac:chgData name="Swati Jagani" userId="S::taitu77@clm.uni-hohenheim.de::1a613237-4fad-448a-82cf-176af2d8d863" providerId="AD" clId="Web-{8C90E00E-52E5-4D41-9152-CA9485C48B60}" dt="2025-09-22T02:21:42.592" v="10"/>
          <ac:picMkLst>
            <pc:docMk/>
            <pc:sldMk cId="2146081360" sldId="277"/>
            <ac:picMk id="3" creationId="{00000000-0000-0000-0000-000000000000}"/>
          </ac:picMkLst>
        </pc:picChg>
      </pc:sldChg>
      <pc:sldChg chg="addSp modSp">
        <pc:chgData name="Swati Jagani" userId="S::taitu77@clm.uni-hohenheim.de::1a613237-4fad-448a-82cf-176af2d8d863" providerId="AD" clId="Web-{8C90E00E-52E5-4D41-9152-CA9485C48B60}" dt="2025-09-22T02:29:49.264" v="90" actId="20577"/>
        <pc:sldMkLst>
          <pc:docMk/>
          <pc:sldMk cId="37551084" sldId="280"/>
        </pc:sldMkLst>
        <pc:spChg chg="mod">
          <ac:chgData name="Swati Jagani" userId="S::taitu77@clm.uni-hohenheim.de::1a613237-4fad-448a-82cf-176af2d8d863" providerId="AD" clId="Web-{8C90E00E-52E5-4D41-9152-CA9485C48B60}" dt="2025-09-22T02:26:58.872" v="30" actId="1076"/>
          <ac:spMkLst>
            <pc:docMk/>
            <pc:sldMk cId="37551084" sldId="280"/>
            <ac:spMk id="2" creationId="{00000000-0000-0000-0000-000000000000}"/>
          </ac:spMkLst>
        </pc:spChg>
        <pc:spChg chg="add mod">
          <ac:chgData name="Swati Jagani" userId="S::taitu77@clm.uni-hohenheim.de::1a613237-4fad-448a-82cf-176af2d8d863" providerId="AD" clId="Web-{8C90E00E-52E5-4D41-9152-CA9485C48B60}" dt="2025-09-22T02:29:49.264" v="90" actId="20577"/>
          <ac:spMkLst>
            <pc:docMk/>
            <pc:sldMk cId="37551084" sldId="280"/>
            <ac:spMk id="4" creationId="{D8E93040-CA6C-E039-B392-1AE1C10D99A6}"/>
          </ac:spMkLst>
        </pc:spChg>
      </pc:sldChg>
      <pc:sldChg chg="addSp modSp">
        <pc:chgData name="Swati Jagani" userId="S::taitu77@clm.uni-hohenheim.de::1a613237-4fad-448a-82cf-176af2d8d863" providerId="AD" clId="Web-{8C90E00E-52E5-4D41-9152-CA9485C48B60}" dt="2025-09-22T02:21:25.092" v="8" actId="1076"/>
        <pc:sldMkLst>
          <pc:docMk/>
          <pc:sldMk cId="3108103837" sldId="282"/>
        </pc:sldMkLst>
        <pc:picChg chg="mod modCrop">
          <ac:chgData name="Swati Jagani" userId="S::taitu77@clm.uni-hohenheim.de::1a613237-4fad-448a-82cf-176af2d8d863" providerId="AD" clId="Web-{8C90E00E-52E5-4D41-9152-CA9485C48B60}" dt="2025-09-22T02:21:19.420" v="7"/>
          <ac:picMkLst>
            <pc:docMk/>
            <pc:sldMk cId="3108103837" sldId="282"/>
            <ac:picMk id="2" creationId="{00000000-0000-0000-0000-000000000000}"/>
          </ac:picMkLst>
        </pc:picChg>
        <pc:picChg chg="add mod modCrop">
          <ac:chgData name="Swati Jagani" userId="S::taitu77@clm.uni-hohenheim.de::1a613237-4fad-448a-82cf-176af2d8d863" providerId="AD" clId="Web-{8C90E00E-52E5-4D41-9152-CA9485C48B60}" dt="2025-09-22T02:21:25.092" v="8" actId="1076"/>
          <ac:picMkLst>
            <pc:docMk/>
            <pc:sldMk cId="3108103837" sldId="282"/>
            <ac:picMk id="3" creationId="{221F8E1B-7A98-01F2-280C-9AF172E9EA60}"/>
          </ac:picMkLst>
        </pc:picChg>
      </pc:sldChg>
    </pc:docChg>
  </pc:docChgLst>
  <pc:docChgLst>
    <pc:chgData name="Swati Jagani" userId="S::taitu77@clm.uni-hohenheim.de::1a613237-4fad-448a-82cf-176af2d8d863" providerId="AD" clId="Web-{F8CF513D-B7E9-4732-B8C8-05125A88D756}"/>
    <pc:docChg chg="delSld modSld">
      <pc:chgData name="Swati Jagani" userId="S::taitu77@clm.uni-hohenheim.de::1a613237-4fad-448a-82cf-176af2d8d863" providerId="AD" clId="Web-{F8CF513D-B7E9-4732-B8C8-05125A88D756}" dt="2025-07-29T08:38:41.175" v="61" actId="1076"/>
      <pc:docMkLst>
        <pc:docMk/>
      </pc:docMkLst>
      <pc:sldChg chg="modSp">
        <pc:chgData name="Swati Jagani" userId="S::taitu77@clm.uni-hohenheim.de::1a613237-4fad-448a-82cf-176af2d8d863" providerId="AD" clId="Web-{F8CF513D-B7E9-4732-B8C8-05125A88D756}" dt="2025-07-29T08:35:04.543" v="28" actId="20577"/>
        <pc:sldMkLst>
          <pc:docMk/>
          <pc:sldMk cId="463524538" sldId="257"/>
        </pc:sldMkLst>
      </pc:sldChg>
      <pc:sldChg chg="addSp modSp">
        <pc:chgData name="Swati Jagani" userId="S::taitu77@clm.uni-hohenheim.de::1a613237-4fad-448a-82cf-176af2d8d863" providerId="AD" clId="Web-{F8CF513D-B7E9-4732-B8C8-05125A88D756}" dt="2025-07-29T08:37:15.172" v="49" actId="20577"/>
        <pc:sldMkLst>
          <pc:docMk/>
          <pc:sldMk cId="3533398411" sldId="259"/>
        </pc:sldMkLst>
      </pc:sldChg>
      <pc:sldChg chg="del">
        <pc:chgData name="Swati Jagani" userId="S::taitu77@clm.uni-hohenheim.de::1a613237-4fad-448a-82cf-176af2d8d863" providerId="AD" clId="Web-{F8CF513D-B7E9-4732-B8C8-05125A88D756}" dt="2025-07-29T08:36:05.561" v="36"/>
        <pc:sldMkLst>
          <pc:docMk/>
          <pc:sldMk cId="948378089" sldId="260"/>
        </pc:sldMkLst>
      </pc:sldChg>
      <pc:sldChg chg="del">
        <pc:chgData name="Swati Jagani" userId="S::taitu77@clm.uni-hohenheim.de::1a613237-4fad-448a-82cf-176af2d8d863" providerId="AD" clId="Web-{F8CF513D-B7E9-4732-B8C8-05125A88D756}" dt="2025-07-29T08:35:05.090" v="29"/>
        <pc:sldMkLst>
          <pc:docMk/>
          <pc:sldMk cId="2649929649" sldId="261"/>
        </pc:sldMkLst>
      </pc:sldChg>
      <pc:sldChg chg="addSp modSp">
        <pc:chgData name="Swati Jagani" userId="S::taitu77@clm.uni-hohenheim.de::1a613237-4fad-448a-82cf-176af2d8d863" providerId="AD" clId="Web-{F8CF513D-B7E9-4732-B8C8-05125A88D756}" dt="2025-07-29T08:38:41.175" v="61" actId="1076"/>
        <pc:sldMkLst>
          <pc:docMk/>
          <pc:sldMk cId="3723493265" sldId="262"/>
        </pc:sldMkLst>
      </pc:sldChg>
      <pc:sldChg chg="del">
        <pc:chgData name="Swati Jagani" userId="S::taitu77@clm.uni-hohenheim.de::1a613237-4fad-448a-82cf-176af2d8d863" providerId="AD" clId="Web-{F8CF513D-B7E9-4732-B8C8-05125A88D756}" dt="2025-07-29T08:37:57.111" v="57"/>
        <pc:sldMkLst>
          <pc:docMk/>
          <pc:sldMk cId="2417684488" sldId="263"/>
        </pc:sldMkLst>
      </pc:sldChg>
      <pc:sldChg chg="addSp delSp modSp">
        <pc:chgData name="Swati Jagani" userId="S::taitu77@clm.uni-hohenheim.de::1a613237-4fad-448a-82cf-176af2d8d863" providerId="AD" clId="Web-{F8CF513D-B7E9-4732-B8C8-05125A88D756}" dt="2025-07-29T08:37:55.908" v="56" actId="1076"/>
        <pc:sldMkLst>
          <pc:docMk/>
          <pc:sldMk cId="2963017621" sldId="264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F9259A-1FE3-4FF9-8A07-BDD8177164ED}" type="datetime4">
              <a:rPr lang="en-US" smtClean="0"/>
              <a:t>October 3, 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AEF59-F28E-467C-9EA3-92D1CFAD4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335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C3C8F-D4A7-4EAD-92AD-82C91CB8BB85}" type="datetime4">
              <a:rPr lang="en-US" smtClean="0"/>
              <a:t>October 3, 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AEF59-F28E-467C-9EA3-92D1CFAD4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5556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11D41-E33C-4BC7-8272-37E8417FD097}" type="datetime4">
              <a:rPr lang="en-US" smtClean="0"/>
              <a:t>October 3, 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AEF59-F28E-467C-9EA3-92D1CFAD4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9020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40FED-6E95-4177-A7EF-CD303B9E611D}" type="datetime4">
              <a:rPr lang="en-US" smtClean="0"/>
              <a:t>October 3, 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AEF59-F28E-467C-9EA3-92D1CFAD4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7555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962CB-39AD-45A9-800F-54DAB53D6021}" type="datetime4">
              <a:rPr lang="en-US" smtClean="0"/>
              <a:t>October 3, 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AEF59-F28E-467C-9EA3-92D1CFAD4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066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DF93D-55AB-4606-B9D7-742F1FC51983}" type="datetime4">
              <a:rPr lang="en-US" smtClean="0"/>
              <a:t>October 3, 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AEF59-F28E-467C-9EA3-92D1CFAD475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55736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2841D-FB5C-47AB-B2FF-32E855C1EA71}" type="datetime4">
              <a:rPr lang="en-US" smtClean="0"/>
              <a:t>October 3, 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AEF59-F28E-467C-9EA3-92D1CFAD4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805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537E9-D174-424D-BEE8-AFC4CA5F9F97}" type="datetime4">
              <a:rPr lang="en-US" smtClean="0"/>
              <a:t>October 3, 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AEF59-F28E-467C-9EA3-92D1CFAD4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7287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A44C0-F7AC-49C2-8289-1E7A86D9FB50}" type="datetime4">
              <a:rPr lang="en-US" smtClean="0"/>
              <a:t>October 3, 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AEF59-F28E-467C-9EA3-92D1CFAD4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6141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B84BC-6E78-40D1-8831-40AB1F596614}" type="datetime4">
              <a:rPr lang="en-US" smtClean="0"/>
              <a:t>October 3, 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AEF59-F28E-467C-9EA3-92D1CFAD4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7633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A080F-3961-4D42-BEDE-84A1FED032F1}" type="datetime4">
              <a:rPr lang="en-US" smtClean="0"/>
              <a:t>October 3, 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AEF59-F28E-467C-9EA3-92D1CFAD4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986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3960BD-7AC1-4217-9611-AAA56D3EE38F}" type="datetime4">
              <a:rPr lang="en-US" smtClean="0"/>
              <a:pPr/>
              <a:t>October 3, 2025</a:t>
            </a:fld>
            <a:endParaRPr lang="en-US" dirty="0">
              <a:latin typeface="+mn-lt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>
              <a:latin typeface="+mn-lt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4AEF59-F28E-467C-9EA3-92D1CFAD475A}" type="slidenum">
              <a:rPr lang="en-US" smtClean="0"/>
              <a:pPr/>
              <a:t>‹#›</a:t>
            </a:fld>
            <a:endParaRPr lang="en-US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1012768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3" r:id="rId1"/>
    <p:sldLayoutId id="2147483754" r:id="rId2"/>
    <p:sldLayoutId id="2147483755" r:id="rId3"/>
    <p:sldLayoutId id="2147483756" r:id="rId4"/>
    <p:sldLayoutId id="2147483757" r:id="rId5"/>
    <p:sldLayoutId id="2147483758" r:id="rId6"/>
    <p:sldLayoutId id="2147483759" r:id="rId7"/>
    <p:sldLayoutId id="2147483760" r:id="rId8"/>
    <p:sldLayoutId id="2147483761" r:id="rId9"/>
    <p:sldLayoutId id="2147483762" r:id="rId10"/>
    <p:sldLayoutId id="2147483763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0372" y="310243"/>
            <a:ext cx="11293928" cy="6057901"/>
          </a:xfrm>
        </p:spPr>
        <p:txBody>
          <a:bodyPr>
            <a:normAutofit/>
          </a:bodyPr>
          <a:lstStyle/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Viroid Ecology in Hops (</a:t>
            </a:r>
            <a:r>
              <a:rPr lang="en-US" sz="2800" b="1" i="1" dirty="0">
                <a:latin typeface="Arial" panose="020B0604020202020204" pitchFamily="34" charset="0"/>
                <a:cs typeface="Arial" panose="020B0604020202020204" pitchFamily="34" charset="0"/>
              </a:rPr>
              <a:t>Humulus</a:t>
            </a: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800" b="1" i="1" dirty="0">
                <a:latin typeface="Arial" panose="020B0604020202020204" pitchFamily="34" charset="0"/>
                <a:cs typeface="Arial" panose="020B0604020202020204" pitchFamily="34" charset="0"/>
              </a:rPr>
              <a:t>lupulus</a:t>
            </a: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 L): High Prevalence in Commercial Systems but Low Presence in Wild Populations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uthors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wati Jagani </a:t>
            </a:r>
            <a:r>
              <a:rPr lang="en-GB" sz="2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Christina Krönauer </a:t>
            </a:r>
            <a:r>
              <a:rPr lang="en-GB" sz="2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Ute Born </a:t>
            </a:r>
            <a:r>
              <a:rPr lang="en-GB" sz="2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Michael Helmut Hagemann </a:t>
            </a:r>
            <a:r>
              <a:rPr lang="en-GB" sz="2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br>
              <a:rPr lang="en-GB" sz="2000" b="1" baseline="30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20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GB" sz="2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20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University of Hohenheim, Production Systems of Horticultural Crops, Emil-Wolff-Str. </a:t>
            </a:r>
            <a:r>
              <a:rPr lang="de-DE" sz="2000" dirty="0">
                <a:latin typeface="Arial" panose="020B0604020202020204" pitchFamily="34" charset="0"/>
                <a:cs typeface="Arial" panose="020B0604020202020204" pitchFamily="34" charset="0"/>
              </a:rPr>
              <a:t>25, 70599 Stuttgart, Germany</a:t>
            </a:r>
            <a:r>
              <a:rPr lang="en-GB" sz="20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GB" sz="2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2000" baseline="30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de-DE" sz="2000" dirty="0">
                <a:latin typeface="Arial" panose="020B0604020202020204" pitchFamily="34" charset="0"/>
                <a:cs typeface="Arial" panose="020B0604020202020204" pitchFamily="34" charset="0"/>
              </a:rPr>
              <a:t>Bayerische Landesanstalt für Landwirtschaft, Institute for Crop Science and Plant Breeding, Huell 5 1/3, 85283 Wolnzach</a:t>
            </a:r>
            <a:endParaRPr lang="en-GB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116152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55445" y="2284236"/>
            <a:ext cx="1905000" cy="1325563"/>
          </a:xfrm>
        </p:spPr>
        <p:txBody>
          <a:bodyPr/>
          <a:lstStyle/>
          <a:p>
            <a:r>
              <a:rPr lang="de-DE" b="1" dirty="0"/>
              <a:t>Viorids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11960288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951B357-2A31-2412-98CB-DDACCB3C71FF}"/>
              </a:ext>
            </a:extLst>
          </p:cNvPr>
          <p:cNvSpPr txBox="1"/>
          <p:nvPr/>
        </p:nvSpPr>
        <p:spPr>
          <a:xfrm>
            <a:off x="173735" y="237744"/>
            <a:ext cx="11765715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2000" b="1" dirty="0">
                <a:solidFill>
                  <a:srgbClr val="FF0000"/>
                </a:solidFill>
                <a:latin typeface="Arial"/>
                <a:cs typeface="Arial"/>
              </a:rPr>
              <a:t>Hop Latent Viroid,</a:t>
            </a:r>
            <a:r>
              <a:rPr lang="en-GB" sz="1600" b="1" dirty="0">
                <a:latin typeface="Arial"/>
                <a:cs typeface="Arial"/>
              </a:rPr>
              <a:t> pp609, Testing of different cDNA dilutions with HLVd to prove that the samples work in pools of 1:10, size- 250</a:t>
            </a:r>
            <a:endParaRPr lang="en-US" sz="1600" b="1" dirty="0">
              <a:latin typeface="Arial"/>
              <a:cs typeface="Arial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2604" y="965237"/>
            <a:ext cx="10811795" cy="58927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058490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951B357-2A31-2412-98CB-DDACCB3C71FF}"/>
              </a:ext>
            </a:extLst>
          </p:cNvPr>
          <p:cNvSpPr txBox="1"/>
          <p:nvPr/>
        </p:nvSpPr>
        <p:spPr>
          <a:xfrm>
            <a:off x="173735" y="237744"/>
            <a:ext cx="11765715" cy="40011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2000" b="1" dirty="0">
                <a:solidFill>
                  <a:srgbClr val="FF0000"/>
                </a:solidFill>
                <a:latin typeface="Arial"/>
                <a:cs typeface="Arial"/>
              </a:rPr>
              <a:t>Hop Stunt Viroid; 3 primer pairs used for hop and grape, </a:t>
            </a:r>
            <a:r>
              <a:rPr lang="en-GB" sz="2000" b="1">
                <a:solidFill>
                  <a:srgbClr val="FF0000"/>
                </a:solidFill>
                <a:latin typeface="Arial"/>
                <a:cs typeface="Arial"/>
              </a:rPr>
              <a:t>1:10 dilution</a:t>
            </a:r>
            <a:endParaRPr lang="en-US" sz="1600" b="1" dirty="0">
              <a:latin typeface="Arial"/>
              <a:cs typeface="Arial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-126" t="9257" b="28585"/>
          <a:stretch>
            <a:fillRect/>
          </a:stretch>
        </p:blipFill>
        <p:spPr>
          <a:xfrm>
            <a:off x="176507" y="936978"/>
            <a:ext cx="11349453" cy="3927555"/>
          </a:xfrm>
          <a:prstGeom prst="rect">
            <a:avLst/>
          </a:prstGeom>
        </p:spPr>
      </p:pic>
      <p:pic>
        <p:nvPicPr>
          <p:cNvPr id="3" name="Picture 2" descr="A screenshot of a test&#10;&#10;AI-generated content may be incorrect.">
            <a:extLst>
              <a:ext uri="{FF2B5EF4-FFF2-40B4-BE49-F238E27FC236}">
                <a16:creationId xmlns:a16="http://schemas.microsoft.com/office/drawing/2014/main" id="{221F8E1B-7A98-01F2-280C-9AF172E9EA6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9285" r="70993" b="6311"/>
          <a:stretch>
            <a:fillRect/>
          </a:stretch>
        </p:blipFill>
        <p:spPr>
          <a:xfrm>
            <a:off x="93297" y="4534326"/>
            <a:ext cx="3288011" cy="1542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810383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-321" t="979" b="19576"/>
          <a:stretch>
            <a:fillRect/>
          </a:stretch>
        </p:blipFill>
        <p:spPr>
          <a:xfrm>
            <a:off x="180967" y="1320800"/>
            <a:ext cx="11638510" cy="431435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951B357-2A31-2412-98CB-DDACCB3C71FF}"/>
              </a:ext>
            </a:extLst>
          </p:cNvPr>
          <p:cNvSpPr txBox="1"/>
          <p:nvPr/>
        </p:nvSpPr>
        <p:spPr>
          <a:xfrm>
            <a:off x="173735" y="237744"/>
            <a:ext cx="11765715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2000" b="1" dirty="0">
                <a:solidFill>
                  <a:srgbClr val="FF0000"/>
                </a:solidFill>
                <a:latin typeface="Arial"/>
                <a:cs typeface="Arial"/>
              </a:rPr>
              <a:t>Hop Stunt Viroid,</a:t>
            </a:r>
            <a:r>
              <a:rPr lang="en-GB" sz="1600" b="1" dirty="0">
                <a:latin typeface="Arial"/>
                <a:cs typeface="Arial"/>
              </a:rPr>
              <a:t> pp609, Testing of different cDNA dilutions with HSVd to prove that the samples work in pools of 1:10, size- 171</a:t>
            </a:r>
            <a:endParaRPr lang="en-US" sz="1600" b="1" dirty="0">
              <a:latin typeface="Arial"/>
              <a:cs typeface="Arial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5476672" y="5651770"/>
            <a:ext cx="1692613" cy="758757"/>
            <a:chOff x="7597302" y="4756826"/>
            <a:chExt cx="1692613" cy="758757"/>
          </a:xfrm>
          <a:solidFill>
            <a:schemeClr val="accent6">
              <a:lumMod val="60000"/>
              <a:lumOff val="40000"/>
            </a:schemeClr>
          </a:solidFill>
        </p:grpSpPr>
        <p:sp>
          <p:nvSpPr>
            <p:cNvPr id="6" name="Rectangular Callout 5"/>
            <p:cNvSpPr/>
            <p:nvPr/>
          </p:nvSpPr>
          <p:spPr>
            <a:xfrm>
              <a:off x="7607030" y="4756826"/>
              <a:ext cx="1673157" cy="758757"/>
            </a:xfrm>
            <a:prstGeom prst="wedgeRectCallout">
              <a:avLst>
                <a:gd name="adj1" fmla="val 32655"/>
                <a:gd name="adj2" fmla="val -183654"/>
              </a:avLst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7597302" y="4756826"/>
              <a:ext cx="1692613" cy="646331"/>
            </a:xfrm>
            <a:prstGeom prst="rect">
              <a:avLst/>
            </a:prstGeom>
            <a:grp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dirty="0" smtClean="0"/>
                <a:t>Negative </a:t>
              </a:r>
              <a:r>
                <a:rPr lang="de-DE" smtClean="0"/>
                <a:t>clean sample</a:t>
              </a:r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21460813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4900" y="3947230"/>
            <a:ext cx="2367844" cy="1325563"/>
          </a:xfrm>
        </p:spPr>
        <p:txBody>
          <a:bodyPr/>
          <a:lstStyle/>
          <a:p>
            <a:r>
              <a:rPr lang="de-DE" b="1" dirty="0"/>
              <a:t>Viruses</a:t>
            </a:r>
            <a:endParaRPr lang="en-GB" b="1" dirty="0"/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D8E93040-CA6C-E039-B392-1AE1C10D99A6}"/>
              </a:ext>
            </a:extLst>
          </p:cNvPr>
          <p:cNvSpPr txBox="1">
            <a:spLocks/>
          </p:cNvSpPr>
          <p:nvPr/>
        </p:nvSpPr>
        <p:spPr>
          <a:xfrm>
            <a:off x="812800" y="617713"/>
            <a:ext cx="10696927" cy="35846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lnSpc>
                <a:spcPct val="150000"/>
              </a:lnSpc>
            </a:pPr>
            <a:r>
              <a:rPr lang="de-DE" sz="2400" b="1" dirty="0" smtClean="0">
                <a:latin typeface="+mn-lt"/>
                <a:ea typeface="+mj-lt"/>
                <a:cs typeface="+mj-lt"/>
              </a:rPr>
              <a:t>Presentation _1_PCR </a:t>
            </a:r>
            <a:r>
              <a:rPr lang="de-DE" sz="2400" b="1" dirty="0">
                <a:latin typeface="+mn-lt"/>
                <a:ea typeface="+mj-lt"/>
                <a:cs typeface="+mj-lt"/>
              </a:rPr>
              <a:t>examples</a:t>
            </a:r>
            <a:endParaRPr lang="en-US" sz="5400" b="1" dirty="0" err="1">
              <a:latin typeface="+mn-lt"/>
            </a:endParaRPr>
          </a:p>
          <a:p>
            <a:pPr algn="just">
              <a:lnSpc>
                <a:spcPct val="150000"/>
              </a:lnSpc>
            </a:pPr>
            <a:r>
              <a:rPr lang="de-DE" sz="1800" dirty="0">
                <a:latin typeface="+mn-lt"/>
                <a:ea typeface="+mj-lt"/>
                <a:cs typeface="+mj-lt"/>
              </a:rPr>
              <a:t>This presentation provides pictures of PCR results for the detection of various viroids and viruses. </a:t>
            </a:r>
            <a:endParaRPr lang="de-DE" dirty="0">
              <a:latin typeface="+mn-lt"/>
              <a:ea typeface="Calibri Light"/>
              <a:cs typeface="Calibri Light"/>
            </a:endParaRPr>
          </a:p>
          <a:p>
            <a:pPr marL="285750" indent="-285750" algn="just">
              <a:lnSpc>
                <a:spcPct val="150000"/>
              </a:lnSpc>
              <a:buFont typeface="Arial"/>
              <a:buChar char="•"/>
            </a:pPr>
            <a:r>
              <a:rPr lang="de-DE" sz="1800" dirty="0">
                <a:latin typeface="+mn-lt"/>
                <a:ea typeface="+mj-lt"/>
                <a:cs typeface="+mj-lt"/>
              </a:rPr>
              <a:t>The optimal dilution for achieving clear, strong target bands.</a:t>
            </a:r>
            <a:endParaRPr lang="de-DE" sz="1800" dirty="0">
              <a:latin typeface="+mn-lt"/>
              <a:ea typeface="Calibri Light"/>
              <a:cs typeface="Calibri Light"/>
            </a:endParaRPr>
          </a:p>
          <a:p>
            <a:pPr marL="273050" indent="-273050">
              <a:lnSpc>
                <a:spcPct val="150000"/>
              </a:lnSpc>
              <a:buFont typeface="Arial"/>
              <a:buChar char="•"/>
            </a:pPr>
            <a:r>
              <a:rPr lang="de-DE" sz="1800" dirty="0">
                <a:latin typeface="+mn-lt"/>
                <a:ea typeface="+mj-lt"/>
                <a:cs typeface="+mj-lt"/>
              </a:rPr>
              <a:t>The visualization of target pathogen DNA/RNA fragments</a:t>
            </a:r>
            <a:r>
              <a:rPr lang="de-DE" sz="1800" dirty="0" smtClean="0">
                <a:latin typeface="+mn-lt"/>
                <a:ea typeface="+mj-lt"/>
                <a:cs typeface="+mj-lt"/>
              </a:rPr>
              <a:t>.</a:t>
            </a:r>
            <a:br>
              <a:rPr lang="de-DE" sz="1800" dirty="0" smtClean="0">
                <a:latin typeface="+mn-lt"/>
                <a:ea typeface="+mj-lt"/>
                <a:cs typeface="+mj-lt"/>
              </a:rPr>
            </a:br>
            <a:r>
              <a:rPr lang="de-DE" sz="1800" dirty="0" smtClean="0">
                <a:latin typeface="+mn-lt"/>
                <a:ea typeface="+mj-lt"/>
                <a:cs typeface="+mj-lt"/>
              </a:rPr>
              <a:t/>
            </a:r>
            <a:br>
              <a:rPr lang="de-DE" sz="1800" dirty="0" smtClean="0">
                <a:latin typeface="+mn-lt"/>
                <a:ea typeface="+mj-lt"/>
                <a:cs typeface="+mj-lt"/>
              </a:rPr>
            </a:br>
            <a:r>
              <a:rPr lang="de-DE" sz="1800" b="1" i="1" dirty="0" smtClean="0">
                <a:latin typeface="+mn-lt"/>
                <a:ea typeface="+mj-lt"/>
                <a:cs typeface="+mj-lt"/>
              </a:rPr>
              <a:t>NOTE:</a:t>
            </a:r>
            <a:r>
              <a:rPr lang="de-DE" sz="1800" i="1" dirty="0" smtClean="0">
                <a:latin typeface="+mn-lt"/>
                <a:ea typeface="+mj-lt"/>
                <a:cs typeface="+mj-lt"/>
              </a:rPr>
              <a:t> </a:t>
            </a:r>
            <a:r>
              <a:rPr lang="en-GB" sz="1800" i="1" dirty="0">
                <a:latin typeface="+mn-lt"/>
              </a:rPr>
              <a:t>In addition to the no-template controls (NTC), healthy (negative) samples from our study were also tested. These consistently yielded clean gels without any signal, confirming the absence of viroids in negative samples.</a:t>
            </a:r>
            <a:endParaRPr lang="de-DE" sz="1800" i="1" dirty="0">
              <a:latin typeface="+mn-lt"/>
              <a:ea typeface="Calibri Light"/>
              <a:cs typeface="Calibri Light"/>
            </a:endParaRPr>
          </a:p>
          <a:p>
            <a:pPr algn="just">
              <a:lnSpc>
                <a:spcPct val="150000"/>
              </a:lnSpc>
            </a:pPr>
            <a:endParaRPr lang="de-DE" sz="1800" b="1" dirty="0">
              <a:ea typeface="Calibri Light"/>
              <a:cs typeface="Calibri Light"/>
            </a:endParaRPr>
          </a:p>
        </p:txBody>
      </p:sp>
    </p:spTree>
    <p:extLst>
      <p:ext uri="{BB962C8B-B14F-4D97-AF65-F5344CB8AC3E}">
        <p14:creationId xmlns:p14="http://schemas.microsoft.com/office/powerpoint/2010/main" val="375510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3B933A-C1BE-93AF-5EA9-9B55FBF5032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26D6F6F2-D519-5494-7B42-06AF91233C8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2439" b="49920"/>
          <a:stretch>
            <a:fillRect/>
          </a:stretch>
        </p:blipFill>
        <p:spPr>
          <a:xfrm>
            <a:off x="99554" y="1214846"/>
            <a:ext cx="6563641" cy="187844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7141459-27F3-7BDC-955D-753D8E68DC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432" y="3329813"/>
            <a:ext cx="3019846" cy="1086002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2A9DBC71-271A-FAE0-AB62-E4F1E24336E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123" t="7855"/>
          <a:stretch/>
        </p:blipFill>
        <p:spPr>
          <a:xfrm>
            <a:off x="6861600" y="1175657"/>
            <a:ext cx="5124149" cy="3627560"/>
          </a:xfrm>
          <a:prstGeom prst="rect">
            <a:avLst/>
          </a:prstGeom>
        </p:spPr>
      </p:pic>
      <p:sp>
        <p:nvSpPr>
          <p:cNvPr id="67" name="TextBox 66">
            <a:extLst>
              <a:ext uri="{FF2B5EF4-FFF2-40B4-BE49-F238E27FC236}">
                <a16:creationId xmlns:a16="http://schemas.microsoft.com/office/drawing/2014/main" id="{2951B357-2A31-2412-98CB-DDACCB3C71FF}"/>
              </a:ext>
            </a:extLst>
          </p:cNvPr>
          <p:cNvSpPr txBox="1"/>
          <p:nvPr/>
        </p:nvSpPr>
        <p:spPr>
          <a:xfrm>
            <a:off x="173735" y="237744"/>
            <a:ext cx="11765715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2000" b="1" dirty="0">
                <a:solidFill>
                  <a:srgbClr val="FF0000"/>
                </a:solidFill>
                <a:latin typeface="Arial"/>
                <a:cs typeface="Arial"/>
              </a:rPr>
              <a:t>Hop latent virus,</a:t>
            </a:r>
            <a:r>
              <a:rPr lang="en-GB" sz="1600" b="1" dirty="0">
                <a:latin typeface="Arial"/>
                <a:cs typeface="Arial"/>
              </a:rPr>
              <a:t> pp542, Testing of different cDNA dilutions with HpLV to prove that the samples work in pools of 1:10, size-900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903B521C-1E9F-7BF0-350F-A51B627B4DD9}"/>
              </a:ext>
            </a:extLst>
          </p:cNvPr>
          <p:cNvSpPr txBox="1"/>
          <p:nvPr/>
        </p:nvSpPr>
        <p:spPr>
          <a:xfrm>
            <a:off x="6726936" y="4919041"/>
            <a:ext cx="5297424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Gel Electrophoresis Conditions: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1.2% agarose gel, 100 ml, stained with 5 µl </a:t>
            </a:r>
            <a:r>
              <a:rPr lang="en-GB" sz="1600" dirty="0" err="1">
                <a:latin typeface="Arial" panose="020B0604020202020204" pitchFamily="34" charset="0"/>
                <a:cs typeface="Arial" panose="020B0604020202020204" pitchFamily="34" charset="0"/>
              </a:rPr>
              <a:t>peqGreen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2 µl 5× loading dye + 10 µl PCR product, 10 µl loaded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5 µl 100 bp ladder (NEB), 100 V, run for 60-80 minutes for all pathogens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03B521C-1E9F-7BF0-350F-A51B627B4DD9}"/>
              </a:ext>
            </a:extLst>
          </p:cNvPr>
          <p:cNvSpPr txBox="1"/>
          <p:nvPr/>
        </p:nvSpPr>
        <p:spPr>
          <a:xfrm>
            <a:off x="112776" y="4980001"/>
            <a:ext cx="5297424" cy="7853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Control was pre verfied HpLV positive Hop RNA from another lab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6070059" y="4095345"/>
            <a:ext cx="1692613" cy="758757"/>
            <a:chOff x="7597302" y="4756826"/>
            <a:chExt cx="1692613" cy="758757"/>
          </a:xfrm>
          <a:solidFill>
            <a:schemeClr val="accent6">
              <a:lumMod val="60000"/>
              <a:lumOff val="40000"/>
            </a:schemeClr>
          </a:solidFill>
        </p:grpSpPr>
        <p:sp>
          <p:nvSpPr>
            <p:cNvPr id="9" name="Rectangular Callout 8"/>
            <p:cNvSpPr/>
            <p:nvPr/>
          </p:nvSpPr>
          <p:spPr>
            <a:xfrm>
              <a:off x="7607030" y="4756826"/>
              <a:ext cx="1673157" cy="758757"/>
            </a:xfrm>
            <a:prstGeom prst="wedgeRectCallout">
              <a:avLst>
                <a:gd name="adj1" fmla="val 32655"/>
                <a:gd name="adj2" fmla="val -183654"/>
              </a:avLst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7597302" y="4756826"/>
              <a:ext cx="1692613" cy="646331"/>
            </a:xfrm>
            <a:prstGeom prst="rect">
              <a:avLst/>
            </a:prstGeom>
            <a:grp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dirty="0" smtClean="0"/>
                <a:t>Negative </a:t>
              </a:r>
              <a:r>
                <a:rPr lang="de-DE" smtClean="0"/>
                <a:t>clean sample</a:t>
              </a:r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4635245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3B933A-C1BE-93AF-5EA9-9B55FBF5032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66">
            <a:extLst>
              <a:ext uri="{FF2B5EF4-FFF2-40B4-BE49-F238E27FC236}">
                <a16:creationId xmlns:a16="http://schemas.microsoft.com/office/drawing/2014/main" id="{2951B357-2A31-2412-98CB-DDACCB3C71FF}"/>
              </a:ext>
            </a:extLst>
          </p:cNvPr>
          <p:cNvSpPr txBox="1"/>
          <p:nvPr/>
        </p:nvSpPr>
        <p:spPr>
          <a:xfrm>
            <a:off x="173735" y="237744"/>
            <a:ext cx="11765715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2000" b="1" dirty="0">
                <a:solidFill>
                  <a:srgbClr val="FF0000"/>
                </a:solidFill>
                <a:latin typeface="Arial"/>
                <a:cs typeface="Arial"/>
              </a:rPr>
              <a:t>Hop mosaic virus,</a:t>
            </a:r>
            <a:r>
              <a:rPr lang="en-GB" sz="1600" b="1" dirty="0">
                <a:latin typeface="Arial"/>
                <a:cs typeface="Arial"/>
              </a:rPr>
              <a:t>    pp551, Testing of different cDNA dilutions with HpMV to prove that the samples work in pools of 1:10, size-882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03B521C-1E9F-7BF0-350F-A51B627B4DD9}"/>
              </a:ext>
            </a:extLst>
          </p:cNvPr>
          <p:cNvSpPr txBox="1"/>
          <p:nvPr/>
        </p:nvSpPr>
        <p:spPr>
          <a:xfrm>
            <a:off x="112776" y="4980001"/>
            <a:ext cx="5297424" cy="7853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Control was pre verfied HpMV positive Hop RNA from another lab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5688" t="151" b="14793"/>
          <a:stretch>
            <a:fillRect/>
          </a:stretch>
        </p:blipFill>
        <p:spPr>
          <a:xfrm>
            <a:off x="6914936" y="1148330"/>
            <a:ext cx="4737318" cy="349883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443" y="1149488"/>
            <a:ext cx="6598677" cy="195947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315" y="3304331"/>
            <a:ext cx="3112010" cy="12154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51623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3B933A-C1BE-93AF-5EA9-9B55FBF5032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66">
            <a:extLst>
              <a:ext uri="{FF2B5EF4-FFF2-40B4-BE49-F238E27FC236}">
                <a16:creationId xmlns:a16="http://schemas.microsoft.com/office/drawing/2014/main" id="{2951B357-2A31-2412-98CB-DDACCB3C71FF}"/>
              </a:ext>
            </a:extLst>
          </p:cNvPr>
          <p:cNvSpPr txBox="1"/>
          <p:nvPr/>
        </p:nvSpPr>
        <p:spPr>
          <a:xfrm>
            <a:off x="173735" y="237744"/>
            <a:ext cx="11765715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2000" b="1" dirty="0">
                <a:solidFill>
                  <a:srgbClr val="FF0000"/>
                </a:solidFill>
                <a:latin typeface="Arial"/>
                <a:cs typeface="Arial"/>
              </a:rPr>
              <a:t>Apple Mosaic Virus,</a:t>
            </a:r>
            <a:r>
              <a:rPr lang="en-GB" sz="1600" b="1" dirty="0">
                <a:latin typeface="Arial"/>
                <a:cs typeface="Arial"/>
              </a:rPr>
              <a:t> pp561, Testing of different cDNA dilutions with ApMV to prove that the samples work in pools of 1:10, size- 830</a:t>
            </a:r>
            <a:endParaRPr lang="en-US" sz="1600" b="1" dirty="0">
              <a:latin typeface="Arial"/>
              <a:cs typeface="Arial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1FBB0C8-D1AC-335F-3B28-F457F7D2EB5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78" t="10490" r="40931" b="61834"/>
          <a:stretch/>
        </p:blipFill>
        <p:spPr>
          <a:xfrm>
            <a:off x="262251" y="1108800"/>
            <a:ext cx="6390549" cy="17928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1FBB0C8-D1AC-335F-3B28-F457F7D2EB5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19" t="41148" r="59473" b="19840"/>
          <a:stretch/>
        </p:blipFill>
        <p:spPr>
          <a:xfrm>
            <a:off x="7120800" y="1108800"/>
            <a:ext cx="4600800" cy="30168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1FBB0C8-D1AC-335F-3B28-F457F7D2EB5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9754" t="10490" r="13050" b="69411"/>
          <a:stretch/>
        </p:blipFill>
        <p:spPr>
          <a:xfrm>
            <a:off x="324000" y="3046800"/>
            <a:ext cx="3096000" cy="130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24259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36325" t="2915" r="1121" b="39206"/>
          <a:stretch/>
        </p:blipFill>
        <p:spPr>
          <a:xfrm>
            <a:off x="4478400" y="691200"/>
            <a:ext cx="7496400" cy="37152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951B357-2A31-2412-98CB-DDACCB3C71FF}"/>
              </a:ext>
            </a:extLst>
          </p:cNvPr>
          <p:cNvSpPr txBox="1"/>
          <p:nvPr/>
        </p:nvSpPr>
        <p:spPr>
          <a:xfrm>
            <a:off x="173735" y="237744"/>
            <a:ext cx="11765715" cy="40011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2000" b="1" dirty="0">
                <a:solidFill>
                  <a:srgbClr val="FF0000"/>
                </a:solidFill>
                <a:latin typeface="Arial"/>
                <a:cs typeface="Arial"/>
              </a:rPr>
              <a:t>Apple mosaic virus,</a:t>
            </a:r>
            <a:r>
              <a:rPr lang="en-GB" sz="1600" b="1" dirty="0">
                <a:latin typeface="Arial"/>
                <a:cs typeface="Arial"/>
              </a:rPr>
              <a:t> Test samples, 1:10 dilution </a:t>
            </a:r>
            <a:endParaRPr lang="en-US" sz="1600" b="1" dirty="0">
              <a:latin typeface="Arial"/>
              <a:cs typeface="Arial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/>
          <a:srcRect t="77344" r="71405" b="3760"/>
          <a:stretch/>
        </p:blipFill>
        <p:spPr>
          <a:xfrm>
            <a:off x="140771" y="5968800"/>
            <a:ext cx="2451229" cy="8676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/>
          <a:srcRect t="2916" r="70293" b="26773"/>
          <a:stretch/>
        </p:blipFill>
        <p:spPr>
          <a:xfrm>
            <a:off x="90371" y="627600"/>
            <a:ext cx="4241555" cy="5377200"/>
          </a:xfrm>
          <a:prstGeom prst="rect">
            <a:avLst/>
          </a:prstGeom>
        </p:spPr>
      </p:pic>
      <p:grpSp>
        <p:nvGrpSpPr>
          <p:cNvPr id="6" name="Group 5"/>
          <p:cNvGrpSpPr/>
          <p:nvPr/>
        </p:nvGrpSpPr>
        <p:grpSpPr>
          <a:xfrm>
            <a:off x="8852170" y="4688732"/>
            <a:ext cx="1692613" cy="758757"/>
            <a:chOff x="7597302" y="4756826"/>
            <a:chExt cx="1692613" cy="758757"/>
          </a:xfrm>
          <a:solidFill>
            <a:schemeClr val="accent6">
              <a:lumMod val="60000"/>
              <a:lumOff val="40000"/>
            </a:schemeClr>
          </a:solidFill>
        </p:grpSpPr>
        <p:sp>
          <p:nvSpPr>
            <p:cNvPr id="3" name="Rectangular Callout 2"/>
            <p:cNvSpPr/>
            <p:nvPr/>
          </p:nvSpPr>
          <p:spPr>
            <a:xfrm>
              <a:off x="7607030" y="4756826"/>
              <a:ext cx="1673157" cy="758757"/>
            </a:xfrm>
            <a:prstGeom prst="wedgeRectCallout">
              <a:avLst>
                <a:gd name="adj1" fmla="val 32655"/>
                <a:gd name="adj2" fmla="val -183654"/>
              </a:avLst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7597302" y="4756826"/>
              <a:ext cx="1692613" cy="646331"/>
            </a:xfrm>
            <a:prstGeom prst="rect">
              <a:avLst/>
            </a:prstGeom>
            <a:grp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dirty="0" smtClean="0"/>
                <a:t>Negative clean samples</a:t>
              </a:r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11972951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3B933A-C1BE-93AF-5EA9-9B55FBF5032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66">
            <a:extLst>
              <a:ext uri="{FF2B5EF4-FFF2-40B4-BE49-F238E27FC236}">
                <a16:creationId xmlns:a16="http://schemas.microsoft.com/office/drawing/2014/main" id="{2951B357-2A31-2412-98CB-DDACCB3C71FF}"/>
              </a:ext>
            </a:extLst>
          </p:cNvPr>
          <p:cNvSpPr txBox="1"/>
          <p:nvPr/>
        </p:nvSpPr>
        <p:spPr>
          <a:xfrm>
            <a:off x="173735" y="237744"/>
            <a:ext cx="11765715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2000" b="1" dirty="0">
                <a:solidFill>
                  <a:srgbClr val="FF0000"/>
                </a:solidFill>
                <a:latin typeface="Arial"/>
                <a:cs typeface="Arial"/>
              </a:rPr>
              <a:t>American Hop Latent Virus,</a:t>
            </a:r>
            <a:r>
              <a:rPr lang="en-GB" sz="1600" b="1" dirty="0">
                <a:latin typeface="Arial"/>
                <a:cs typeface="Arial"/>
              </a:rPr>
              <a:t>    pp558, Testing of different cDNA dilutions with AHpLV to prove that the samples work in pools of 1:10, size- 932</a:t>
            </a:r>
            <a:endParaRPr lang="en-US" sz="1600" b="1" dirty="0">
              <a:latin typeface="Arial"/>
              <a:cs typeface="Arial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4794" t="40197" r="59179" b="12885"/>
          <a:stretch/>
        </p:blipFill>
        <p:spPr>
          <a:xfrm>
            <a:off x="7427960" y="1072800"/>
            <a:ext cx="4315240" cy="31968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2"/>
          <a:srcRect l="2516" t="6599" r="38590" b="62253"/>
          <a:stretch/>
        </p:blipFill>
        <p:spPr>
          <a:xfrm>
            <a:off x="151199" y="954000"/>
            <a:ext cx="6572205" cy="19692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"/>
          <a:srcRect l="62353" t="9043" r="8592" b="69932"/>
          <a:stretch/>
        </p:blipFill>
        <p:spPr>
          <a:xfrm>
            <a:off x="50400" y="2793600"/>
            <a:ext cx="3793600" cy="1555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47587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3B933A-C1BE-93AF-5EA9-9B55FBF5032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66">
            <a:extLst>
              <a:ext uri="{FF2B5EF4-FFF2-40B4-BE49-F238E27FC236}">
                <a16:creationId xmlns:a16="http://schemas.microsoft.com/office/drawing/2014/main" id="{2951B357-2A31-2412-98CB-DDACCB3C71FF}"/>
              </a:ext>
            </a:extLst>
          </p:cNvPr>
          <p:cNvSpPr txBox="1"/>
          <p:nvPr/>
        </p:nvSpPr>
        <p:spPr>
          <a:xfrm>
            <a:off x="173735" y="237744"/>
            <a:ext cx="11765715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2000" b="1" dirty="0">
                <a:solidFill>
                  <a:srgbClr val="FF0000"/>
                </a:solidFill>
                <a:latin typeface="Arial"/>
                <a:cs typeface="Arial"/>
              </a:rPr>
              <a:t>Arabis Mosaic Virus,</a:t>
            </a:r>
            <a:r>
              <a:rPr lang="en-GB" sz="1600" b="1" dirty="0">
                <a:latin typeface="Arial"/>
                <a:cs typeface="Arial"/>
              </a:rPr>
              <a:t>    pp535, Testing of different cDNA dilutions with AHpLV to prove that the samples work in pools of 1:10, size- 213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03B521C-1E9F-7BF0-350F-A51B627B4DD9}"/>
              </a:ext>
            </a:extLst>
          </p:cNvPr>
          <p:cNvSpPr txBox="1"/>
          <p:nvPr/>
        </p:nvSpPr>
        <p:spPr>
          <a:xfrm>
            <a:off x="112776" y="4980001"/>
            <a:ext cx="529742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The ArMV samples were tested in 3 different dilutions and 1:10 was selected for consequent PCRs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295" y="1055303"/>
            <a:ext cx="5654530" cy="154699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6096" y="2720297"/>
            <a:ext cx="2613887" cy="97544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13293" y="954475"/>
            <a:ext cx="6220663" cy="36386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347740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3B933A-C1BE-93AF-5EA9-9B55FBF5032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66">
            <a:extLst>
              <a:ext uri="{FF2B5EF4-FFF2-40B4-BE49-F238E27FC236}">
                <a16:creationId xmlns:a16="http://schemas.microsoft.com/office/drawing/2014/main" id="{2951B357-2A31-2412-98CB-DDACCB3C71FF}"/>
              </a:ext>
            </a:extLst>
          </p:cNvPr>
          <p:cNvSpPr txBox="1"/>
          <p:nvPr/>
        </p:nvSpPr>
        <p:spPr>
          <a:xfrm>
            <a:off x="173735" y="237744"/>
            <a:ext cx="11765715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2000" b="1" dirty="0">
                <a:solidFill>
                  <a:srgbClr val="FF0000"/>
                </a:solidFill>
                <a:latin typeface="Arial"/>
                <a:cs typeface="Arial"/>
              </a:rPr>
              <a:t>Arabis Mosaic Virus,</a:t>
            </a:r>
            <a:r>
              <a:rPr lang="en-GB" sz="1600" b="1" dirty="0">
                <a:latin typeface="Arial"/>
                <a:cs typeface="Arial"/>
              </a:rPr>
              <a:t>    </a:t>
            </a:r>
            <a:r>
              <a:rPr lang="en-GB" sz="1600" b="1" dirty="0" smtClean="0">
                <a:latin typeface="Arial"/>
                <a:cs typeface="Arial"/>
              </a:rPr>
              <a:t>pp572, </a:t>
            </a:r>
            <a:r>
              <a:rPr lang="en-GB" sz="1600" b="1" dirty="0">
                <a:latin typeface="Arial"/>
                <a:cs typeface="Arial"/>
              </a:rPr>
              <a:t>Testing of different cDNA dilutions with AHpLV to prove that the samples work in pools of 1:10, size- </a:t>
            </a:r>
            <a:r>
              <a:rPr lang="en-GB" sz="1600" b="1" dirty="0" smtClean="0">
                <a:latin typeface="Arial"/>
                <a:cs typeface="Arial"/>
              </a:rPr>
              <a:t>525</a:t>
            </a:r>
            <a:endParaRPr lang="en-US" sz="1600" b="1" dirty="0">
              <a:latin typeface="Arial"/>
              <a:cs typeface="Arial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9060" y="1009391"/>
            <a:ext cx="4555895" cy="321241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97619" y="1032953"/>
            <a:ext cx="2613887" cy="99830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4590" y="4357991"/>
            <a:ext cx="9385051" cy="2341776"/>
          </a:xfrm>
          <a:prstGeom prst="rect">
            <a:avLst/>
          </a:prstGeom>
        </p:spPr>
      </p:pic>
      <p:grpSp>
        <p:nvGrpSpPr>
          <p:cNvPr id="6" name="Group 5"/>
          <p:cNvGrpSpPr/>
          <p:nvPr/>
        </p:nvGrpSpPr>
        <p:grpSpPr>
          <a:xfrm>
            <a:off x="6001968" y="3083666"/>
            <a:ext cx="1673157" cy="758757"/>
            <a:chOff x="7607030" y="4756826"/>
            <a:chExt cx="1673157" cy="758757"/>
          </a:xfrm>
          <a:solidFill>
            <a:schemeClr val="accent6">
              <a:lumMod val="60000"/>
              <a:lumOff val="40000"/>
            </a:schemeClr>
          </a:solidFill>
        </p:grpSpPr>
        <p:sp>
          <p:nvSpPr>
            <p:cNvPr id="8" name="Rectangular Callout 7"/>
            <p:cNvSpPr/>
            <p:nvPr/>
          </p:nvSpPr>
          <p:spPr>
            <a:xfrm>
              <a:off x="7607030" y="4756826"/>
              <a:ext cx="1673157" cy="758757"/>
            </a:xfrm>
            <a:prstGeom prst="wedgeRectCallout">
              <a:avLst>
                <a:gd name="adj1" fmla="val -279545"/>
                <a:gd name="adj2" fmla="val 260179"/>
              </a:avLst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636215" y="4844374"/>
              <a:ext cx="1575877" cy="646331"/>
            </a:xfrm>
            <a:prstGeom prst="rect">
              <a:avLst/>
            </a:prstGeom>
            <a:grp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dirty="0" smtClean="0"/>
                <a:t>Negative clean samples</a:t>
              </a:r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1480472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14b174c4-cd78-4e8f-a46c-e56803eb4c35">
      <Terms xmlns="http://schemas.microsoft.com/office/infopath/2007/PartnerControls"/>
    </lcf76f155ced4ddcb4097134ff3c332f>
    <TaxCatchAll xmlns="090e463d-6295-411b-8a34-9db847c5ad55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F6601537F500347A3CB1F94EA34817A" ma:contentTypeVersion="13" ma:contentTypeDescription="Create a new document." ma:contentTypeScope="" ma:versionID="bdc5f599af0b3ebc290a222801105b25">
  <xsd:schema xmlns:xsd="http://www.w3.org/2001/XMLSchema" xmlns:xs="http://www.w3.org/2001/XMLSchema" xmlns:p="http://schemas.microsoft.com/office/2006/metadata/properties" xmlns:ns2="14b174c4-cd78-4e8f-a46c-e56803eb4c35" xmlns:ns3="090e463d-6295-411b-8a34-9db847c5ad55" targetNamespace="http://schemas.microsoft.com/office/2006/metadata/properties" ma:root="true" ma:fieldsID="058d7810aacf5b74a661fb3382602240" ns2:_="" ns3:_="">
    <xsd:import namespace="14b174c4-cd78-4e8f-a46c-e56803eb4c35"/>
    <xsd:import namespace="090e463d-6295-411b-8a34-9db847c5ad55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MediaServiceDateTaken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Location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4b174c4-cd78-4e8f-a46c-e56803eb4c3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c6a84dbc-1963-4dd9-961a-a26084293e72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9" nillable="true" ma:displayName="Location" ma:indexed="true" ma:internalName="MediaServiceLocatio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90e463d-6295-411b-8a34-9db847c5ad55" elementFormDefault="qualified">
    <xsd:import namespace="http://schemas.microsoft.com/office/2006/documentManagement/types"/>
    <xsd:import namespace="http://schemas.microsoft.com/office/infopath/2007/PartnerControls"/>
    <xsd:element name="TaxCatchAll" ma:index="17" nillable="true" ma:displayName="Taxonomy Catch All Column" ma:hidden="true" ma:list="{d808d965-1a9c-476e-b4e4-09b3c23bf638}" ma:internalName="TaxCatchAll" ma:showField="CatchAllData" ma:web="090e463d-6295-411b-8a34-9db847c5ad55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B3D3484-80AC-4230-AAB7-546A2B978303}">
  <ds:schemaRefs>
    <ds:schemaRef ds:uri="http://purl.org/dc/terms/"/>
    <ds:schemaRef ds:uri="http://www.w3.org/XML/1998/namespace"/>
    <ds:schemaRef ds:uri="http://purl.org/dc/elements/1.1/"/>
    <ds:schemaRef ds:uri="http://schemas.microsoft.com/office/2006/metadata/properties"/>
    <ds:schemaRef ds:uri="http://purl.org/dc/dcmitype/"/>
    <ds:schemaRef ds:uri="http://schemas.microsoft.com/office/2006/documentManagement/types"/>
    <ds:schemaRef ds:uri="14b174c4-cd78-4e8f-a46c-e56803eb4c35"/>
    <ds:schemaRef ds:uri="http://schemas.microsoft.com/office/infopath/2007/PartnerControls"/>
    <ds:schemaRef ds:uri="http://schemas.openxmlformats.org/package/2006/metadata/core-properties"/>
    <ds:schemaRef ds:uri="090e463d-6295-411b-8a34-9db847c5ad55"/>
  </ds:schemaRefs>
</ds:datastoreItem>
</file>

<file path=customXml/itemProps2.xml><?xml version="1.0" encoding="utf-8"?>
<ds:datastoreItem xmlns:ds="http://schemas.openxmlformats.org/officeDocument/2006/customXml" ds:itemID="{1EEE8C9B-5217-4842-A4A1-9687E67BB2D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05BB1557-0A01-4E57-9C9B-50183705A7F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4b174c4-cd78-4e8f-a46c-e56803eb4c35"/>
    <ds:schemaRef ds:uri="090e463d-6295-411b-8a34-9db847c5ad5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244</Words>
  <Application>Microsoft Office PowerPoint</Application>
  <PresentationFormat>Widescreen</PresentationFormat>
  <Paragraphs>28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rial</vt:lpstr>
      <vt:lpstr>Calibri</vt:lpstr>
      <vt:lpstr>Calibri Light</vt:lpstr>
      <vt:lpstr>Office Theme</vt:lpstr>
      <vt:lpstr>Viroid Ecology in Hops (Humulus lupulus L): High Prevalence in Commercial Systems but Low Presence in Wild Populations  Authors Swati Jagani 1, Christina Krönauer 2, Ute Born 1, Michael Helmut Hagemann 1  1 University of Hohenheim, Production Systems of Horticultural Crops, Emil-Wolff-Str. 25, 70599 Stuttgart, Germany 2 Bayerische Landesanstalt für Landwirtschaft, Institute for Crop Science and Plant Breeding, Huell 5 1/3, 85283 Wolnzach</vt:lpstr>
      <vt:lpstr>Virus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Viorids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wati Jagani</dc:creator>
  <cp:lastModifiedBy>Swati Jagani</cp:lastModifiedBy>
  <cp:revision>102</cp:revision>
  <dcterms:created xsi:type="dcterms:W3CDTF">2025-07-24T13:36:13Z</dcterms:created>
  <dcterms:modified xsi:type="dcterms:W3CDTF">2025-10-03T03:47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F6601537F500347A3CB1F94EA34817A</vt:lpwstr>
  </property>
  <property fmtid="{D5CDD505-2E9C-101B-9397-08002B2CF9AE}" pid="3" name="MediaServiceImageTags">
    <vt:lpwstr/>
  </property>
</Properties>
</file>